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  <p:sldId id="261" r:id="rId4"/>
    <p:sldId id="262" r:id="rId5"/>
    <p:sldId id="256" r:id="rId6"/>
    <p:sldId id="257" r:id="rId7"/>
    <p:sldId id="258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200" d="100"/>
          <a:sy n="200" d="100"/>
        </p:scale>
        <p:origin x="47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6581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49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9408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25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277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781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430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351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125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422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620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CA9C10-32AB-4A8F-A80C-FEA8814448F5}" type="datetimeFigureOut">
              <a:rPr lang="en-US" smtClean="0"/>
              <a:t>3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1781D-EF2C-4247-9292-60AA3CD2DB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513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8566201"/>
              </p:ext>
            </p:extLst>
          </p:nvPr>
        </p:nvGraphicFramePr>
        <p:xfrm>
          <a:off x="326983" y="456347"/>
          <a:ext cx="6291072" cy="937914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72768">
                  <a:extLst>
                    <a:ext uri="{9D8B030D-6E8A-4147-A177-3AD203B41FA5}">
                      <a16:colId xmlns:a16="http://schemas.microsoft.com/office/drawing/2014/main" val="664419349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967516569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3599729824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267218429"/>
                    </a:ext>
                  </a:extLst>
                </a:gridCol>
              </a:tblGrid>
              <a:tr h="191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-1-B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ase Na+/K+ transporting subunit alph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lreticu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tilage acidic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59075301"/>
                  </a:ext>
                </a:extLst>
              </a:tr>
              <a:tr h="191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-2-macroglobu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ase Na+/K+ transporting subunit alpha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tal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ystatin C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471210884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tin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 synthase F1 subunit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D14 molecul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thepsin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317139938"/>
                  </a:ext>
                </a:extLst>
              </a:tr>
              <a:tr h="2292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tin beta lik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ase H+ transporting accessory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D163 molecul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thepsin 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2309171652"/>
                  </a:ext>
                </a:extLst>
              </a:tr>
              <a:tr h="2292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tin alpha cardiac muscl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ase H+ transporting accessory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D5 molecule lik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rmcid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660033670"/>
                  </a:ext>
                </a:extLst>
              </a:tr>
              <a:tr h="7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tinin alpha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tract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dherin 1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co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083576984"/>
                  </a:ext>
                </a:extLst>
              </a:tr>
              <a:tr h="191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E binding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XL receptor tyrosine kin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ickkopf WNT signaling pathway inhibitor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268675691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fam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-2-glycoprotein 1, zinc-bindin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ipeptidyl peptidase 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532803856"/>
                  </a:ext>
                </a:extLst>
              </a:tr>
              <a:tr h="11581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eta-2-microglobu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H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smocoll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511159761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ngiotensinoge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eta-1,4-glucuronyltransfer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I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smogl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2408611914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 2-HS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revica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properd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smoplak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2610845280"/>
                  </a:ext>
                </a:extLst>
              </a:tr>
              <a:tr h="11581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bum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leomycin hydrol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romogranin 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xtracellular matrix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897329492"/>
                  </a:ext>
                </a:extLst>
              </a:tr>
              <a:tr h="2292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dehyde dehydrogenase 3 family member A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iotinid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romogranin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ukaryotic translation elongation facto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767609172"/>
                  </a:ext>
                </a:extLst>
              </a:tr>
              <a:tr h="191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dolase, fructose-bisphosphate 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itinase 3 lik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ukaryotic translation elongation factor 1 alph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2650034590"/>
                  </a:ext>
                </a:extLst>
              </a:tr>
              <a:tr h="191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dolase, fructose-bisphosphate C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ell adhesion molecule L1 lik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ukaryotic translation elongation factor 1 gamm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393583528"/>
                  </a:ext>
                </a:extLst>
              </a:tr>
              <a:tr h="2292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-1-microglobulin/bikunin precurso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reatine kinase, M-typ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GF containing fibulin extracellular matrix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9479220"/>
                  </a:ext>
                </a:extLst>
              </a:tr>
              <a:tr h="2292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nnexin A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-type lectin domain family 3 member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GF containing fibulin extracellular matrix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4180832780"/>
                  </a:ext>
                </a:extLst>
              </a:tr>
              <a:tr h="7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nnexin A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lsynten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nol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79006025"/>
                  </a:ext>
                </a:extLst>
              </a:tr>
              <a:tr h="78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nnexin A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luste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nolase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186745228"/>
                  </a:ext>
                </a:extLst>
              </a:tr>
              <a:tr h="2292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mine oxidase copper containing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romosome 16 open reading frame 8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nosine dipeptid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ctonucleotide pyrophosphatase/phosphodiesteras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891174185"/>
                  </a:ext>
                </a:extLst>
              </a:tr>
              <a:tr h="191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myloid P component, serum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romosome 1 open reading frame 6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ntact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xostosin like glycosyltransferas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565160634"/>
                  </a:ext>
                </a:extLst>
              </a:tr>
              <a:tr h="191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myloid beta precursor like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q 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ntact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z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408870614"/>
                  </a:ext>
                </a:extLst>
              </a:tr>
              <a:tr h="191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myloid beta precursor like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q B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ntact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II, prothromb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848652551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A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q C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collagen type XII alpha 1 chain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V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85075777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A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I alpha 1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IX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2706062337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I alpha 2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X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410329903"/>
                  </a:ext>
                </a:extLst>
              </a:tr>
              <a:tr h="19145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C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4A (Rodgers blood group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collagen type III alpha 1 chain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XII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551832511"/>
                  </a:ext>
                </a:extLst>
              </a:tr>
              <a:tr h="2292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C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omponent 4 binding protein alph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VI alpha 1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XIII B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2198964559"/>
                  </a:ext>
                </a:extLst>
              </a:tr>
              <a:tr h="22927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omponent 4 binding protein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VI alpha 2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tty acid binding protein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288774590"/>
                  </a:ext>
                </a:extLst>
              </a:tr>
              <a:tr h="2670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8 alph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VI alpha 3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M3 metabolism regulating signaling molecule C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2109315412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H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8 bet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tilage oligomeric matrix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tty acid synth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142915098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M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8 gamm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eruloplasm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T atypical cadher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2915449715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myloid beta precursor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bonic anhydr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boxypeptidase 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bul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2725668407"/>
                  </a:ext>
                </a:extLst>
              </a:tr>
              <a:tr h="3049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rgin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lcium voltage-gated channel auxiliary subunit alpha2delt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boxypeptidase N subunit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bul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1633333118"/>
                  </a:ext>
                </a:extLst>
              </a:tr>
              <a:tr h="15363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aspartic peptidase retroviral like 1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calmodulin</a:t>
                      </a:r>
                      <a:r>
                        <a:rPr lang="en-US" sz="1000" u="none" strike="noStrike" dirty="0">
                          <a:effectLst/>
                        </a:rPr>
                        <a:t> like 5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cornulin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fibulin</a:t>
                      </a:r>
                      <a:r>
                        <a:rPr lang="en-US" sz="1000" u="none" strike="noStrike" dirty="0">
                          <a:effectLst/>
                        </a:rPr>
                        <a:t> 5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64" marR="2364" marT="2364" marB="0" anchor="b"/>
                </a:tc>
                <a:extLst>
                  <a:ext uri="{0D108BD9-81ED-4DB2-BD59-A6C34878D82A}">
                    <a16:rowId xmlns:a16="http://schemas.microsoft.com/office/drawing/2014/main" val="398575295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-1" y="63500"/>
            <a:ext cx="66180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Table S1: </a:t>
            </a:r>
            <a:r>
              <a:rPr lang="en-US" sz="1200" dirty="0"/>
              <a:t>List of proteins identified in CSF-derived EVs in control monkeys. </a:t>
            </a:r>
          </a:p>
        </p:txBody>
      </p:sp>
    </p:spTree>
    <p:extLst>
      <p:ext uri="{BB962C8B-B14F-4D97-AF65-F5344CB8AC3E}">
        <p14:creationId xmlns:p14="http://schemas.microsoft.com/office/powerpoint/2010/main" val="855934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8514876"/>
              </p:ext>
            </p:extLst>
          </p:nvPr>
        </p:nvGraphicFramePr>
        <p:xfrm>
          <a:off x="239149" y="174987"/>
          <a:ext cx="6291072" cy="951858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72768">
                  <a:extLst>
                    <a:ext uri="{9D8B030D-6E8A-4147-A177-3AD203B41FA5}">
                      <a16:colId xmlns:a16="http://schemas.microsoft.com/office/drawing/2014/main" val="474470202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2869475526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2162040886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623975621"/>
                    </a:ext>
                  </a:extLst>
                </a:gridCol>
              </a:tblGrid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brill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moglobin subunit del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heavy variable 3-7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allikrein B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943987188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c fragment of IgG binding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moglobin subunit gamm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heavy variable 3-7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ininoge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385200488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col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xosaminidase subunit alph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heavy variable 3-64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ocyte proline rich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096173424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col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xosaminidase subunit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heavy variable 4-3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851763580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etuin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GF activato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heavy variable 5-5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813259110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brinogen alph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terogeneous nuclear ribonucleoprotein A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constant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4033935617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brinogen bet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aptoglob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variable 1-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428961473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broblast growth factor recepto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mopex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variable 1-1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092804751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brinogen gamm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istidine rich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variable 1-2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1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904795310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our and a half LIM domains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orne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variable 2-2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1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648441167"/>
                  </a:ext>
                </a:extLst>
              </a:tr>
              <a:tr h="26284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laggrin family membe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at shock protein 90 alpha family class A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variable 2-4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1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356095636"/>
                  </a:ext>
                </a:extLst>
              </a:tr>
              <a:tr h="26284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lagg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at shock protein 90 alpha family class B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variable 3-1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1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300284774"/>
                  </a:ext>
                </a:extLst>
              </a:tr>
              <a:tr h="2256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ibronect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at shock protein 90 beta family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variable 3-2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1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964225393"/>
                  </a:ext>
                </a:extLst>
              </a:tr>
              <a:tr h="2256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ollistatin lik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at shock protein family A (Hsp70) member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variable 3D-1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3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902164094"/>
                  </a:ext>
                </a:extLst>
              </a:tr>
              <a:tr h="2256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ollistatin like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at shock protein family A (Hsp70) member 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kappa variable 3D-2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7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31784826"/>
                  </a:ext>
                </a:extLst>
              </a:tr>
              <a:tr h="2256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lyceraldehyde-3-phosphate dehydrogen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at shock protein family B (small)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lambda constant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7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974721270"/>
                  </a:ext>
                </a:extLst>
              </a:tr>
              <a:tr h="2256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rowth arrest specific 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at shock protein family D (Hsp60)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lambda like polypeptid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7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506678264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uanylate binding protein family member 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eparan sulfate proteoglyca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lambda variable 2-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7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511472659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C vitamin D binding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duronate 2-sulfat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lambda variable 3-2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7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84473544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lial fibrillary acidic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sulin like growth facto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lambda variable 7-4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8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4276715646"/>
                  </a:ext>
                </a:extLst>
              </a:tr>
              <a:tr h="26284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amma-glutamyl hydrol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sulin like growth factor binding protein acid labile subunit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lambda variable 8-6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6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966495943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lucosamine (N-acetyl)-6-sulfat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sulin like growth factor binding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superfamily member 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eratin 6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384080798"/>
                  </a:ext>
                </a:extLst>
              </a:tr>
              <a:tr h="2256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lutamic-oxaloacetic transamin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sulin like growth factor binding prote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ter-alpha-trypsin inhibitor heavy cha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aminin subunit alpha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262084764"/>
                  </a:ext>
                </a:extLst>
              </a:tr>
              <a:tr h="2256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lucose-6-phosphate isomer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sulin like growth factor binding protein 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ter-alpha-trypsin inhibitor heavy cha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aminin subunit alpha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176090829"/>
                  </a:ext>
                </a:extLst>
              </a:tr>
              <a:tr h="2256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lutathione peroxidase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sulin like growth factor binding protein 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ter-alpha-trypsin inhibitor heavy cha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aminin subunit bet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067144973"/>
                  </a:ext>
                </a:extLst>
              </a:tr>
              <a:tr h="22562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elso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heavy constant alph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ter-alpha-trypsin inhibitor heavy cha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aminin subunit beta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826203680"/>
                  </a:ext>
                </a:extLst>
              </a:tr>
              <a:tr h="26284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lutathione S-transferase pi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heavy constant gamma 2 (G2m marker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nter-alpha-trypsin inhibitor heavy chain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aminin subunit gamm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876777458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2B clustered histone 1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heavy constant mu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joining chain of multimeric IgA and IgM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aminin subunit gamma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891826385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istidine ammonia-ly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mmunoglobulin heavy variable 3-2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junction plakoglob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ecithin-cholesterol acyltransfer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663148006"/>
                  </a:ext>
                </a:extLst>
              </a:tr>
              <a:tr h="1884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hemoglobin subunit beta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mmunoglobulin heavy variable 3-49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err="1">
                          <a:effectLst/>
                        </a:rPr>
                        <a:t>kallikrein</a:t>
                      </a:r>
                      <a:r>
                        <a:rPr lang="en-US" sz="1000" u="none" strike="noStrike" dirty="0">
                          <a:effectLst/>
                        </a:rPr>
                        <a:t> related peptidase 6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lactate dehydrogenase A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5675785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15297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3546449"/>
              </p:ext>
            </p:extLst>
          </p:nvPr>
        </p:nvGraphicFramePr>
        <p:xfrm>
          <a:off x="309488" y="288985"/>
          <a:ext cx="6291072" cy="923915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72768">
                  <a:extLst>
                    <a:ext uri="{9D8B030D-6E8A-4147-A177-3AD203B41FA5}">
                      <a16:colId xmlns:a16="http://schemas.microsoft.com/office/drawing/2014/main" val="4170539126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3971083489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3275543340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276796054"/>
                    </a:ext>
                  </a:extLst>
                </a:gridCol>
              </a:tblGrid>
              <a:tr h="16172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actate dehydrogenase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>
                          <a:effectLst/>
                        </a:rPr>
                        <a:t>neural cell adhesion molecule 1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hosphoglycerate kin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ibonuclease T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027168633"/>
                  </a:ext>
                </a:extLst>
              </a:tr>
              <a:tr h="28115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FNG O-fucosylpeptide 3-beta-N-acetylglucosaminyltransfer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 dirty="0">
                          <a:effectLst/>
                        </a:rPr>
                        <a:t>neural </a:t>
                      </a:r>
                      <a:r>
                        <a:rPr lang="fr-FR" sz="1000" u="none" strike="noStrike" dirty="0" err="1">
                          <a:effectLst/>
                        </a:rPr>
                        <a:t>cell</a:t>
                      </a:r>
                      <a:r>
                        <a:rPr lang="fr-FR" sz="1000" u="none" strike="noStrike" dirty="0">
                          <a:effectLst/>
                        </a:rPr>
                        <a:t> </a:t>
                      </a:r>
                      <a:r>
                        <a:rPr lang="fr-FR" sz="1000" u="none" strike="noStrike" dirty="0" err="1">
                          <a:effectLst/>
                        </a:rPr>
                        <a:t>adhesion</a:t>
                      </a:r>
                      <a:r>
                        <a:rPr lang="fr-FR" sz="1000" u="none" strike="noStrike" dirty="0">
                          <a:effectLst/>
                        </a:rPr>
                        <a:t> </a:t>
                      </a:r>
                      <a:r>
                        <a:rPr lang="fr-FR" sz="1000" u="none" strike="noStrike" dirty="0" err="1">
                          <a:effectLst/>
                        </a:rPr>
                        <a:t>molecule</a:t>
                      </a:r>
                      <a:r>
                        <a:rPr lang="fr-FR" sz="1000" u="none" strike="noStrike" dirty="0">
                          <a:effectLst/>
                        </a:rPr>
                        <a:t> 2</a:t>
                      </a:r>
                      <a:endParaRPr lang="fr-FR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eptidoglycan recognition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100 calcium binding protein A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3509203549"/>
                  </a:ext>
                </a:extLst>
              </a:tr>
              <a:tr h="16172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alect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ural EGFL lik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hosphoglucomut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100 calcium binding protein A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285968863"/>
                  </a:ext>
                </a:extLst>
              </a:tr>
              <a:tr h="20153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alectin 3 binding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ogen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lactin induced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100 calcium binding protein A1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010591829"/>
                  </a:ext>
                </a:extLst>
              </a:tr>
              <a:tr h="28115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alectin 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urofasc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yruvate kinase M1/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omatomedin B and thrombospondin type 1 domain containin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120888170"/>
                  </a:ext>
                </a:extLst>
              </a:tr>
              <a:tr h="12191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ectin, mannose binding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idoge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lakophil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cretogranin III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98200856"/>
                  </a:ext>
                </a:extLst>
              </a:tr>
              <a:tr h="8210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amin A/C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idoge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lasminoge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cretogranin V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098062559"/>
                  </a:ext>
                </a:extLst>
              </a:tr>
              <a:tr h="28115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ipoprotein(a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PC intracellular cholesterol transporte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teolipid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maphorin 7A (John Milton Hagen blood group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799914061"/>
                  </a:ext>
                </a:extLst>
              </a:tr>
              <a:tr h="16172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ipoprotein(a) like 2, pseudogen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uronal pentrax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hospholipid transfer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A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515743264"/>
                  </a:ext>
                </a:extLst>
              </a:tr>
              <a:tr h="16172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DL receptor related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uronal pentraxin recepto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lexin domain containing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A member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512259100"/>
                  </a:ext>
                </a:extLst>
              </a:tr>
              <a:tr h="2413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imbic system associated membrane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uronal cell adhesion molecul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eptidylprolyl isomerase 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B member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899955783"/>
                  </a:ext>
                </a:extLst>
              </a:tr>
              <a:tr h="28115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atent transforming growth factor beta binding prote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urex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eriplak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B member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3918220778"/>
                  </a:ext>
                </a:extLst>
              </a:tr>
              <a:tr h="16172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umica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urex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eroxiredox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B member 1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317391711"/>
                  </a:ext>
                </a:extLst>
              </a:tr>
              <a:tr h="16172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lysozym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urex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eroxiredox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B member 1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068574389"/>
                  </a:ext>
                </a:extLst>
              </a:tr>
              <a:tr h="16172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annosidase alpha class 1A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eurotrim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u="none" strike="noStrike">
                          <a:effectLst/>
                        </a:rPr>
                        <a:t>protein kinase C substrate 80K-H</a:t>
                      </a:r>
                      <a:endParaRPr lang="pt-B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C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162325472"/>
                  </a:ext>
                </a:extLst>
              </a:tr>
              <a:tr h="28115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annosidase alpha class 2A membe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nucleobind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tein C, inactivator of coagulation factors Va and VIII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D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177075775"/>
                  </a:ext>
                </a:extLst>
              </a:tr>
              <a:tr h="20153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BL associated serine prote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out at first homolo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tein 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E membe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338855873"/>
                  </a:ext>
                </a:extLst>
              </a:tr>
              <a:tr h="2413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BL associated serine proteas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osteoglyc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tein Z, vitamin K dependent plasma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F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774413111"/>
                  </a:ext>
                </a:extLst>
              </a:tr>
              <a:tr h="12191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yoglob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olfactomedin like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sapos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F membe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337617487"/>
                  </a:ext>
                </a:extLst>
              </a:tr>
              <a:tr h="12191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alate dehydrogen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osteomodu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staglandin D2 synth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erpin family G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3731531884"/>
                  </a:ext>
                </a:extLst>
              </a:tr>
              <a:tr h="2413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ultiple EGF like domains 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opioid binding protein/cell adhesion molecule lik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leiotroph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tratif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889051006"/>
                  </a:ext>
                </a:extLst>
              </a:tr>
              <a:tr h="2413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icrofibril associated prote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orosomucoid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tein tyrosine phosphatase receptor type 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olute carrier family 5 member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021777624"/>
                  </a:ext>
                </a:extLst>
              </a:tr>
              <a:tr h="28115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ilk fat globule EGF and factor V/VIII domain containin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lyl 4-hydroxylase subunit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tein tyrosine phosphatase receptor type F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ushi, nidogen and EGF like domains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2734098484"/>
                  </a:ext>
                </a:extLst>
              </a:tr>
              <a:tr h="2413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atrix Gla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eptidylglycine alpha-amidating monooxygen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tein tyrosine phosphatase receptor type 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uperoxide dismutase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537558141"/>
                  </a:ext>
                </a:extLst>
              </a:tr>
              <a:tr h="2413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atrix metallopeptidas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apilin, proteoglycan like sulfated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ZP alpha-2-macroglobulin lik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ortilin related VPS10 domain containing recepto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4271199372"/>
                  </a:ext>
                </a:extLst>
              </a:tr>
              <a:tr h="20153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annose receptor C-typ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rocollagen C-endopeptidase enhance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quiescin sulfhydryl oxid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ortilin related recepto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634795477"/>
                  </a:ext>
                </a:extLst>
              </a:tr>
              <a:tr h="2413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annose receptor C typ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000" u="none" strike="noStrike">
                          <a:effectLst/>
                        </a:rPr>
                        <a:t>proprotein convertase subtilisin/kexin type 1 inhibitor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etinol binding prote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PARC lik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1216828326"/>
                  </a:ext>
                </a:extLst>
              </a:tr>
              <a:tr h="32096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oes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hosphatidylethanolamine binding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ee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PARC (osteonectin), cwcv and kazal like domains proteoglyca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4199393666"/>
                  </a:ext>
                </a:extLst>
              </a:tr>
              <a:tr h="24134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yosin heavy chain 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phosphatidylethanolamine binding prote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ibonuclease A family member 1, pancreatic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pond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3497846899"/>
                  </a:ext>
                </a:extLst>
              </a:tr>
              <a:tr h="16172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err="1">
                          <a:effectLst/>
                        </a:rPr>
                        <a:t>myocilin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 err="1">
                          <a:effectLst/>
                        </a:rPr>
                        <a:t>profilin</a:t>
                      </a:r>
                      <a:r>
                        <a:rPr lang="en-US" sz="1000" u="none" strike="noStrike" dirty="0">
                          <a:effectLst/>
                        </a:rPr>
                        <a:t> 1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ribonuclease A family member 4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secreted phosphoprotein 1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88" marR="2488" marT="2488" marB="0" anchor="b"/>
                </a:tc>
                <a:extLst>
                  <a:ext uri="{0D108BD9-81ED-4DB2-BD59-A6C34878D82A}">
                    <a16:rowId xmlns:a16="http://schemas.microsoft.com/office/drawing/2014/main" val="8118275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106864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5414515"/>
              </p:ext>
            </p:extLst>
          </p:nvPr>
        </p:nvGraphicFramePr>
        <p:xfrm>
          <a:off x="295422" y="523957"/>
          <a:ext cx="6291072" cy="4610751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72768">
                  <a:extLst>
                    <a:ext uri="{9D8B030D-6E8A-4147-A177-3AD203B41FA5}">
                      <a16:colId xmlns:a16="http://schemas.microsoft.com/office/drawing/2014/main" val="2242678577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3554549433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711857735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622557256"/>
                    </a:ext>
                  </a:extLst>
                </a:gridCol>
              </a:tblGrid>
              <a:tr h="39543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mall proline rich protein 1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Thy-1 cell surface antigen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ubulin beta 6 class V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V-set and immunoglobulin domain containing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extLst>
                  <a:ext uri="{0D108BD9-81ED-4DB2-BD59-A6C34878D82A}">
                    <a16:rowId xmlns:a16="http://schemas.microsoft.com/office/drawing/2014/main" val="2141716512"/>
                  </a:ext>
                </a:extLst>
              </a:tr>
              <a:tr h="36184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mall proline rich protein 1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IMP metallopeptidase inhibito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ubulin beta 2A class II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vitronect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extLst>
                  <a:ext uri="{0D108BD9-81ED-4DB2-BD59-A6C34878D82A}">
                    <a16:rowId xmlns:a16="http://schemas.microsoft.com/office/drawing/2014/main" val="2214955550"/>
                  </a:ext>
                </a:extLst>
              </a:tr>
              <a:tr h="28527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ushi repeat containing protein X-linke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IMP metallopeptidase inhibito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ubulin beta 4B class IV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von Willebrand facto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extLst>
                  <a:ext uri="{0D108BD9-81ED-4DB2-BD59-A6C34878D82A}">
                    <a16:rowId xmlns:a16="http://schemas.microsoft.com/office/drawing/2014/main" val="501719937"/>
                  </a:ext>
                </a:extLst>
              </a:tr>
              <a:tr h="46727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cavenger receptor cysteine rich family member with 5 domain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enascin XA (pseudogene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ubiquitin like modifier activating enzym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WAP, follistatin/kazal, immunoglobulin, kunitz and netrin domain containing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extLst>
                  <a:ext uri="{0D108BD9-81ED-4DB2-BD59-A6C34878D82A}">
                    <a16:rowId xmlns:a16="http://schemas.microsoft.com/office/drawing/2014/main" val="838372004"/>
                  </a:ext>
                </a:extLst>
              </a:tr>
              <a:tr h="57677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ransfer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enascin X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versica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yrosine 3-monooxygenase/tryptophan 5-monooxygenase activation protein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extLst>
                  <a:ext uri="{0D108BD9-81ED-4DB2-BD59-A6C34878D82A}">
                    <a16:rowId xmlns:a16="http://schemas.microsoft.com/office/drawing/2014/main" val="3428401593"/>
                  </a:ext>
                </a:extLst>
              </a:tr>
              <a:tr h="510249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ransforming growth factor beta induce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ropomyos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valosin containing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yrosine 3-monooxygenase/tryptophan 5-monooxygenase activation protein epsilo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extLst>
                  <a:ext uri="{0D108BD9-81ED-4DB2-BD59-A6C34878D82A}">
                    <a16:rowId xmlns:a16="http://schemas.microsoft.com/office/drawing/2014/main" val="2500567785"/>
                  </a:ext>
                </a:extLst>
              </a:tr>
              <a:tr h="57033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ransglutaminase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ransthyret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VGF nerve growth factor inducibl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yrosine 3-monooxygenase/tryptophan 5-monooxygenase activation protein gamm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extLst>
                  <a:ext uri="{0D108BD9-81ED-4DB2-BD59-A6C34878D82A}">
                    <a16:rowId xmlns:a16="http://schemas.microsoft.com/office/drawing/2014/main" val="746401528"/>
                  </a:ext>
                </a:extLst>
              </a:tr>
              <a:tr h="57414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hrombospond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ubulin alpha 1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viment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tyrosine 3-monooxygenase/tryptophan 5-monooxygenase activation protein th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extLst>
                  <a:ext uri="{0D108BD9-81ED-4DB2-BD59-A6C34878D82A}">
                    <a16:rowId xmlns:a16="http://schemas.microsoft.com/office/drawing/2014/main" val="2445781973"/>
                  </a:ext>
                </a:extLst>
              </a:tr>
              <a:tr h="50761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thrombospondin 2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tubulin beta 3 class III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very low density lipoprotein receptor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tyrosine 3-monooxygenase/tryptophan 5-monooxygenase activation protein zeta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567" marR="5567" marT="5567" marB="0" anchor="b"/>
                </a:tc>
                <a:extLst>
                  <a:ext uri="{0D108BD9-81ED-4DB2-BD59-A6C34878D82A}">
                    <a16:rowId xmlns:a16="http://schemas.microsoft.com/office/drawing/2014/main" val="17795099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904481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-1" y="88900"/>
            <a:ext cx="662940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/>
              <a:t>Table </a:t>
            </a:r>
            <a:r>
              <a:rPr lang="en-US" sz="1200" b="1" dirty="0"/>
              <a:t>S2: </a:t>
            </a:r>
            <a:r>
              <a:rPr lang="en-US" sz="1200" dirty="0"/>
              <a:t>List of proteins identified in CSF-derived EVs in prenatally cocaine-exposed monkeys. 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6083857"/>
              </p:ext>
            </p:extLst>
          </p:nvPr>
        </p:nvGraphicFramePr>
        <p:xfrm>
          <a:off x="192926" y="474262"/>
          <a:ext cx="6291072" cy="9239352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72768">
                  <a:extLst>
                    <a:ext uri="{9D8B030D-6E8A-4147-A177-3AD203B41FA5}">
                      <a16:colId xmlns:a16="http://schemas.microsoft.com/office/drawing/2014/main" val="1643883649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1268530315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1093326217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4217711614"/>
                    </a:ext>
                  </a:extLst>
                </a:gridCol>
              </a:tblGrid>
              <a:tr h="469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-1-B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attractin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dher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rmcid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2404267847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-2-macroglobu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XL receptor tyrosine kin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dherin 1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co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982403139"/>
                  </a:ext>
                </a:extLst>
              </a:tr>
              <a:tr h="2237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tin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-2-glycoprotein 1, zinc-bindin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ell migration inducing hyaluronid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ickkopf WNT signaling pathway inhibitor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2191932862"/>
                  </a:ext>
                </a:extLst>
              </a:tr>
              <a:tr h="1353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tin beta lik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eta-2-microglobu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ipeptidyl peptidase 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880078371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tin alpha cardiac muscl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eta-1,4-glucuronyltransfer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smocoll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2450868027"/>
                  </a:ext>
                </a:extLst>
              </a:tr>
              <a:tr h="911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E binding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revica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H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smogl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575183648"/>
                  </a:ext>
                </a:extLst>
              </a:tr>
              <a:tr h="911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fam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leomycin hydrol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I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esmoplak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01254671"/>
                  </a:ext>
                </a:extLst>
              </a:tr>
              <a:tr h="1353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iotinid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factor properd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xtracellular matrix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2531338451"/>
                  </a:ext>
                </a:extLst>
              </a:tr>
              <a:tr h="2237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ngiotensinoge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romogranin 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ukaryotic translation elongation factor 1 alph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501795062"/>
                  </a:ext>
                </a:extLst>
              </a:tr>
              <a:tr h="2679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 2-HS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romogranin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GF containing fibulin extracellular matrix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3068214286"/>
                  </a:ext>
                </a:extLst>
              </a:tr>
              <a:tr h="2679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bum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itinase 3 lik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GF containing fibulin extracellular matrix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663664435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dolase, fructose-bisphosphate 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ell adhesion molecule L1 lik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nol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94181103"/>
                  </a:ext>
                </a:extLst>
              </a:tr>
              <a:tr h="1353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dolase, fructose-bisphosphate C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reatine kinase, M-typ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nolase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4245805699"/>
                  </a:ext>
                </a:extLst>
              </a:tr>
              <a:tr h="2679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rachidonate 15-lipoxygen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-type lectin domain family 3 member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ctonucleotide pyrophosphatase/phosphodiesteras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249927983"/>
                  </a:ext>
                </a:extLst>
              </a:tr>
              <a:tr h="2237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pha-1-microglobulin/bikunin precurso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romosome 16 open reading frame 8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lsynten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xostosin like glycosyltransferas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386486929"/>
                  </a:ext>
                </a:extLst>
              </a:tr>
              <a:tr h="2237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nnexin A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romosome 1 open reading frame 6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luste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z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203289897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nnexin A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q 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nosine dipeptid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II, prothromb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160077978"/>
                  </a:ext>
                </a:extLst>
              </a:tr>
              <a:tr h="1353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myloid beta precursor like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q B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ntact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V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2071651315"/>
                  </a:ext>
                </a:extLst>
              </a:tr>
              <a:tr h="1353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myloid beta precursor like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q C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ntact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IX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883256740"/>
                  </a:ext>
                </a:extLst>
              </a:tr>
              <a:tr h="911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A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ntact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X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3253847738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A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1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collagen type XII alpha 1 chain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XII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3617005663"/>
                  </a:ext>
                </a:extLst>
              </a:tr>
              <a:tr h="2237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4A (Rodgers blood group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I alpha 1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agulation factor XIII B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2608244071"/>
                  </a:ext>
                </a:extLst>
              </a:tr>
              <a:tr h="26797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C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omponent 4 binding protein alph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I alpha 2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tty acid binding protein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3856766062"/>
                  </a:ext>
                </a:extLst>
              </a:tr>
              <a:tr h="31217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C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omponent 4 binding protein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collagen type III alpha 1 chain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M3 metabolism regulating signaling molecule C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738919543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8 alph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VI alpha 1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T atypical cadher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295426216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8 bet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VI alpha 2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bul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544372070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H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mplement C8 gamm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ollagen type VI alpha 3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bul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4110361594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polipoprotein M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bonic anhydr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tilage oligomeric matrix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bulin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691431449"/>
                  </a:ext>
                </a:extLst>
              </a:tr>
              <a:tr h="3563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myloid beta precursor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lcium voltage-gated channel auxiliary subunit alpha2delt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eruloplasm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brill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3158842058"/>
                  </a:ext>
                </a:extLst>
              </a:tr>
              <a:tr h="1795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rgin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ell adhesion molecule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boxypeptidase 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col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928162962"/>
                  </a:ext>
                </a:extLst>
              </a:tr>
              <a:tr h="1353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ase Na+/K+ transporting subunit alph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lreticu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rtilage acidic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col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763524756"/>
                  </a:ext>
                </a:extLst>
              </a:tr>
              <a:tr h="469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ase Na+/K+ transporting subunit alpha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tal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ystatin C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etuin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3693646069"/>
                  </a:ext>
                </a:extLst>
              </a:tr>
              <a:tr h="13536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 synthase F1 subunit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D14 molecul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thepsin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brinogen alph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896453880"/>
                  </a:ext>
                </a:extLst>
              </a:tr>
              <a:tr h="9116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ase H+ transporting accessory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D163 molecul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thepsin 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brinogen beta cha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1669449506"/>
                  </a:ext>
                </a:extLst>
              </a:tr>
              <a:tr h="2237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ATPase H+ transporting accessory protein 2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CD5 molecule like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cutA</a:t>
                      </a:r>
                      <a:r>
                        <a:rPr lang="en-US" sz="1000" u="none" strike="noStrike" dirty="0">
                          <a:effectLst/>
                        </a:rPr>
                        <a:t> divalent cation tolerance homolog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fibroblast growth factor receptor 1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763" marR="2763" marT="2763" marB="0" anchor="b"/>
                </a:tc>
                <a:extLst>
                  <a:ext uri="{0D108BD9-81ED-4DB2-BD59-A6C34878D82A}">
                    <a16:rowId xmlns:a16="http://schemas.microsoft.com/office/drawing/2014/main" val="8988900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346183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1663978"/>
              </p:ext>
            </p:extLst>
          </p:nvPr>
        </p:nvGraphicFramePr>
        <p:xfrm>
          <a:off x="290403" y="120136"/>
          <a:ext cx="6300216" cy="967098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72768">
                  <a:extLst>
                    <a:ext uri="{9D8B030D-6E8A-4147-A177-3AD203B41FA5}">
                      <a16:colId xmlns:a16="http://schemas.microsoft.com/office/drawing/2014/main" val="348478795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2227288476"/>
                    </a:ext>
                  </a:extLst>
                </a:gridCol>
                <a:gridCol w="1581912">
                  <a:extLst>
                    <a:ext uri="{9D8B030D-6E8A-4147-A177-3AD203B41FA5}">
                      <a16:colId xmlns:a16="http://schemas.microsoft.com/office/drawing/2014/main" val="4171182221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1603493016"/>
                    </a:ext>
                  </a:extLst>
                </a:gridCol>
              </a:tblGrid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fibrinogen gamma chain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at shock protein 90 alpha family class B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lambda constant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7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965269921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our and a half LIM domains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at shock protein 90 beta family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lambda like polypeptid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7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769311119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laggrin family membe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at shock protein family A (Hsp70) member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lambda variable 2-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7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150667814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lagg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at shock protein family A (Hsp70) member 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lambda variable 3-2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7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84712965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ibronect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paran sulfate proteoglyca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lambda variable 7-4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7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368819552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ollistatin lik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duronate 2-sulfat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lambda variable 8-6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8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98369599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ollistatin like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sulin like growth facto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superfamily member 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6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700451031"/>
                  </a:ext>
                </a:extLst>
              </a:tr>
              <a:tr h="3221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lyceraldehyde-3-phosphate dehydrogen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sulin like growth factor binding protein acid labile subunit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ter-alpha-trypsin inhibitor heavy cha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6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4200110751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rowth arrest specific 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sulin like growth factor binding prote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ter-alpha-trypsin inhibitor heavy cha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aminin subunit alpha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459428936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C vitamin D binding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sulin like growth factor binding prote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ter-alpha-trypsin inhibitor heavy cha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aminin subunit alpha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4087387387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lial fibrillary acidic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sulin like growth factor binding protein 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ter-alpha-trypsin inhibitor heavy cha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aminin subunit bet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203345536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amma-glutamyl hydrol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sulin like growth factor binding protein 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nter-alpha-trypsin inhibitor heavy chain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aminin subunit beta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652754445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nn-NO" sz="1000" u="none" strike="noStrike">
                          <a:effectLst/>
                        </a:rPr>
                        <a:t>G protein subunit alpha i2</a:t>
                      </a:r>
                      <a:endParaRPr lang="nn-NO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heavy constant alph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joining chain of multimeric IgA and IgM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aminin subunit gamm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870913936"/>
                  </a:ext>
                </a:extLst>
              </a:tr>
              <a:tr h="3221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lucosamine (N-acetyl)-6-sulfat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heavy constant gamma 2 (G2m marker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junction plakoglob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aminin subunit gamma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608327694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lutamic-oxaloacetic transamin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heavy constant mu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allikrein related peptidase 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ecithin-cholesterol acyltransfer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150671966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lutathione peroxidase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heavy variable 3-2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allikrein related peptidase 1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actate dehydrogenase 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28180718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elso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heavy variable 3-4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allikrein B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actate dehydrogenase 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781061999"/>
                  </a:ext>
                </a:extLst>
              </a:tr>
              <a:tr h="32213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lutathione S-transferase pi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heavy variable 3-7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ininoge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FNG O-fucosylpeptide 3-beta-N-acetylglucosaminyltransfer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28350198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2B clustered histone 1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heavy variable 3-7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ocyte proline rich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alect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4087344593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moglobin subunit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heavy variable 4-3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alectin 3 binding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178494872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moglobin subunit del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kappa constant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ectin, mannose binding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061869255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moglobin subunit gamma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kappa variable 1-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ipoprotein(a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429932577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xosaminidase subunit alph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kappa variable 1-1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ipoprotein(a) like 2, pseudogen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772165715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xosaminidase subunit b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kappa variable 1-2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DL receptor related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715712396"/>
                  </a:ext>
                </a:extLst>
              </a:tr>
              <a:tr h="1918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GF activato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kappa variable 2-2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1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imbic system associated membrane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746466372"/>
                  </a:ext>
                </a:extLst>
              </a:tr>
              <a:tr h="2364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aptoglob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kappa variable 2-4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1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atent transforming growth factor beta binding prote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526175043"/>
                  </a:ext>
                </a:extLst>
              </a:tr>
              <a:tr h="21529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mopex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kappa variable 3-1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1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umica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337876391"/>
                  </a:ext>
                </a:extLst>
              </a:tr>
              <a:tr h="2207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istidine rich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kappa variable 3-20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16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ysozym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2409072385"/>
                  </a:ext>
                </a:extLst>
              </a:tr>
              <a:tr h="2716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orne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mmunoglobulin kappa variable 3D-1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ratin 17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nnosidase alpha class 1A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1358572577"/>
                  </a:ext>
                </a:extLst>
              </a:tr>
              <a:tr h="18959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eat shock protein 90 alpha family class A member 1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immunoglobulin kappa variable 3D-20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keratin 31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mannosidase alpha class 2A member 2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326" marR="2326" marT="2326" marB="0" anchor="b"/>
                </a:tc>
                <a:extLst>
                  <a:ext uri="{0D108BD9-81ED-4DB2-BD59-A6C34878D82A}">
                    <a16:rowId xmlns:a16="http://schemas.microsoft.com/office/drawing/2014/main" val="33243169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150281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3346346"/>
              </p:ext>
            </p:extLst>
          </p:nvPr>
        </p:nvGraphicFramePr>
        <p:xfrm>
          <a:off x="265217" y="121460"/>
          <a:ext cx="6291072" cy="968606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72768">
                  <a:extLst>
                    <a:ext uri="{9D8B030D-6E8A-4147-A177-3AD203B41FA5}">
                      <a16:colId xmlns:a16="http://schemas.microsoft.com/office/drawing/2014/main" val="2803309965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1665780489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580183367"/>
                    </a:ext>
                  </a:extLst>
                </a:gridCol>
                <a:gridCol w="1572768">
                  <a:extLst>
                    <a:ext uri="{9D8B030D-6E8A-4147-A177-3AD203B41FA5}">
                      <a16:colId xmlns:a16="http://schemas.microsoft.com/office/drawing/2014/main" val="345274008"/>
                    </a:ext>
                  </a:extLst>
                </a:gridCol>
              </a:tblGrid>
              <a:tr h="236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BL associated serine prote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ucleobind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tein tyrosine phosphatase receptor type 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pond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557902934"/>
                  </a:ext>
                </a:extLst>
              </a:tr>
              <a:tr h="1587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BL associated serine proteas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out at first homolo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ZP alpha-2-macroglobulin lik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creted phospho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733698530"/>
                  </a:ext>
                </a:extLst>
              </a:tr>
              <a:tr h="275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yoglob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osteoglyc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quiescin sulfhydryl oxid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cavenger receptor cysteine rich family member with 5 domain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986883869"/>
                  </a:ext>
                </a:extLst>
              </a:tr>
              <a:tr h="1196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yelin basic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olfactomedin like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etinol binding prote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ransferr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29766166"/>
                  </a:ext>
                </a:extLst>
              </a:tr>
              <a:tr h="1977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late dehydrogenas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osteomodu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ee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ransforming growth factor beta induce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1883377409"/>
                  </a:ext>
                </a:extLst>
              </a:tr>
              <a:tr h="236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ultiple EGF like domains 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opioid binding protein/cell adhesion molecule lik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ibonuclease A family member 1, pancreatic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hrombospond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986142177"/>
                  </a:ext>
                </a:extLst>
              </a:tr>
              <a:tr h="1587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crofibril associated prote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orosomucoid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ibonuclease A family member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hrombospond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1821214163"/>
                  </a:ext>
                </a:extLst>
              </a:tr>
              <a:tr h="236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lk fat globule EGF and factor V/VIII domain containin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apilin, proteoglycan like sulfated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100 calcium binding protein A8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hy-1 cell surface antige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4035460107"/>
                  </a:ext>
                </a:extLst>
              </a:tr>
              <a:tr h="275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trix Gla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collagen C-endopeptidase enhance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omatomedin B and thrombospondin type 1 domain containing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IMP metallopeptidase inhibito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320925904"/>
                  </a:ext>
                </a:extLst>
              </a:tr>
              <a:tr h="236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trix metallopeptidas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proprotein convertase subtilisin/kexin type 1 inhibitor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cretogranin III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IMP metallopeptidase inhibito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915101480"/>
                  </a:ext>
                </a:extLst>
              </a:tr>
              <a:tr h="1977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nnose receptor C-typ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hosphatidylethanolamine binding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cretogranin V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enascin XA (pseudogene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1674746253"/>
                  </a:ext>
                </a:extLst>
              </a:tr>
              <a:tr h="275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oes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hosphatidylethanolamine binding prote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maphorin 7A (John Milton Hagen blood group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enascin X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731602187"/>
                  </a:ext>
                </a:extLst>
              </a:tr>
              <a:tr h="1196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yosin heavy chain 9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lactin induced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A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ropomyosin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1758673256"/>
                  </a:ext>
                </a:extLst>
              </a:tr>
              <a:tr h="1196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yocil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yruvate kinase M1/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A member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ransthyret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607651068"/>
                  </a:ext>
                </a:extLst>
              </a:tr>
              <a:tr h="158710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neural cell adhesion molecule 1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lakophil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B member 1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bulin alpha 1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310437560"/>
                  </a:ext>
                </a:extLst>
              </a:tr>
              <a:tr h="119643">
                <a:tc>
                  <a:txBody>
                    <a:bodyPr/>
                    <a:lstStyle/>
                    <a:p>
                      <a:pPr algn="ctr" fontAlgn="b"/>
                      <a:r>
                        <a:rPr lang="fr-FR" sz="1000" u="none" strike="noStrike">
                          <a:effectLst/>
                        </a:rPr>
                        <a:t>neural cell adhesion molecule 2</a:t>
                      </a:r>
                      <a:endParaRPr lang="fr-FR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lasminoge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C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bulin beta 3 class III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1208933299"/>
                  </a:ext>
                </a:extLst>
              </a:tr>
              <a:tr h="1196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uronal growth regulato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teolipid prote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D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bulin beta 6 class V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466792619"/>
                  </a:ext>
                </a:extLst>
              </a:tr>
              <a:tr h="1587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ural EGFL like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hospholipid transfer 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E membe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bulin beta 2A class II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1182589633"/>
                  </a:ext>
                </a:extLst>
              </a:tr>
              <a:tr h="1587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ogen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lexin domain containing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F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bulin beta 4B class IVb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001056992"/>
                  </a:ext>
                </a:extLst>
              </a:tr>
              <a:tr h="1587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urofasc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eptidylprolyl isomerase 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F membe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ersica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440873289"/>
                  </a:ext>
                </a:extLst>
              </a:tr>
              <a:tr h="19777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idoge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eroxiredox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G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GF nerve growth factor inducibl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3261277194"/>
                  </a:ext>
                </a:extLst>
              </a:tr>
              <a:tr h="1196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idoge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eroxiredox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rpin family I membe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iment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1410950866"/>
                  </a:ext>
                </a:extLst>
              </a:tr>
              <a:tr h="27591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PC intracellular cholesterol transporter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tein C, inactivator of coagulation factors Va and VIII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olute carrier family 4 member 1 (Diego blood group)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ery low density lipoprotein recepto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4041571541"/>
                  </a:ext>
                </a:extLst>
              </a:tr>
              <a:tr h="236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uronal pentrax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tein S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olute carrier family 5 member 5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-set and immunoglobulin domain containing 4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2248709557"/>
                  </a:ext>
                </a:extLst>
              </a:tr>
              <a:tr h="236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uronal pentraxin recepto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tein Z, vitamin K dependent plasma glycoprote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ushi, nidogen and EGF like domains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itronect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3067020518"/>
                  </a:ext>
                </a:extLst>
              </a:tr>
              <a:tr h="15871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uronal cell adhesion molecul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sapos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uperoxide dismutase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on Willebrand factor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93468544"/>
                  </a:ext>
                </a:extLst>
              </a:tr>
              <a:tr h="3931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urexin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staglandin D2 synthase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ortilin related VPS10 domain containing recepto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WAP, follistatin/kazal, immunoglobulin, kunitz and netrin domain containing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725714525"/>
                  </a:ext>
                </a:extLst>
              </a:tr>
              <a:tr h="3540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urexin 2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leiotrophin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ortilin related receptor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yrosine 3-monooxygenase/tryptophan 5-monooxygenase activation protein th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1466134009"/>
                  </a:ext>
                </a:extLst>
              </a:tr>
              <a:tr h="35404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eurexin 3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tein tyrosine phosphatase receptor type D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PARC like 1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yrosine 3-monooxygenase/tryptophan 5-monooxygenase activation protein zeta</a:t>
                      </a:r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extLst>
                  <a:ext uri="{0D108BD9-81ED-4DB2-BD59-A6C34878D82A}">
                    <a16:rowId xmlns:a16="http://schemas.microsoft.com/office/drawing/2014/main" val="3731192184"/>
                  </a:ext>
                </a:extLst>
              </a:tr>
              <a:tr h="2368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</a:rPr>
                        <a:t>neurotrimin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protein tyrosine phosphatase receptor type F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SPARC (</a:t>
                      </a:r>
                      <a:r>
                        <a:rPr lang="en-US" sz="1000" u="none" strike="noStrike" dirty="0" err="1">
                          <a:effectLst/>
                        </a:rPr>
                        <a:t>osteonectin</a:t>
                      </a:r>
                      <a:r>
                        <a:rPr lang="en-US" sz="1000" u="none" strike="noStrike" dirty="0">
                          <a:effectLst/>
                        </a:rPr>
                        <a:t>), </a:t>
                      </a:r>
                      <a:r>
                        <a:rPr lang="en-US" sz="1000" u="none" strike="noStrike" dirty="0" err="1">
                          <a:effectLst/>
                        </a:rPr>
                        <a:t>cwcv</a:t>
                      </a:r>
                      <a:r>
                        <a:rPr lang="en-US" sz="1000" u="none" strike="noStrike" dirty="0">
                          <a:effectLst/>
                        </a:rPr>
                        <a:t> and </a:t>
                      </a:r>
                      <a:r>
                        <a:rPr lang="en-US" sz="1000" u="none" strike="noStrike" dirty="0" err="1">
                          <a:effectLst/>
                        </a:rPr>
                        <a:t>kazal</a:t>
                      </a:r>
                      <a:r>
                        <a:rPr lang="en-US" sz="1000" u="none" strike="noStrike" dirty="0">
                          <a:effectLst/>
                        </a:rPr>
                        <a:t> like domains proteoglycan 3</a:t>
                      </a:r>
                      <a:endParaRPr lang="en-US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42" marR="2442" marT="2442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26342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30752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</TotalTime>
  <Words>3038</Words>
  <Application>Microsoft Office PowerPoint</Application>
  <PresentationFormat>A4 Paper (210x297 mm)</PresentationFormat>
  <Paragraphs>79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F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lini Mishra</dc:creator>
  <cp:lastModifiedBy>MDPI</cp:lastModifiedBy>
  <cp:revision>18</cp:revision>
  <dcterms:created xsi:type="dcterms:W3CDTF">2022-02-23T20:06:21Z</dcterms:created>
  <dcterms:modified xsi:type="dcterms:W3CDTF">2022-03-28T09:31:25Z</dcterms:modified>
</cp:coreProperties>
</file>